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102475" cy="93884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457E6-27C1-4453-BC93-BFB715640D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13DA0-655B-4C19-BA36-F42408C46D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D2C1F-4154-4F50-B10A-60FD264E74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04451-FADA-4516-9E88-07D7BBF6E3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CFEF5-B18A-4618-9292-1DDAE2DA75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924ED-627C-42C4-BE80-79B5F489E4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4F912-53C9-4726-B258-369545CC73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84B14-39D1-45D5-A7B4-D7B7CDC0B2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5E8CA-73F6-4600-8A1E-D96DF78A49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41109-56CD-4B3A-A000-23DE7A5DDD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8F0CB-800C-42C3-985A-51352C9558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5A4FF-67D7-433C-9EF7-A9F65F185A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9FD38C-8B37-4069-9144-94F945A694E4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1"/>
          <p:cNvSpPr/>
          <p:nvPr/>
        </p:nvSpPr>
        <p:spPr>
          <a:xfrm>
            <a:off x="257040" y="5645160"/>
            <a:ext cx="6228000" cy="103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 | Mesenchymal stromal cells (MSC) from ALL bone marrow promote ALL cell prolifer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L cells were co-cultured on NBM or ALL MSC and their proliferation evaluated by CTV dilution assay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-MN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-M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3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-M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). NBM: Normal Bone Marrow; ALL: Acute Lymphoblastic Leukemia; Mononuclear Cells (MNC); CTV: Cell Trace Viole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39 Grupo"/>
          <p:cNvGrpSpPr/>
          <p:nvPr/>
        </p:nvGrpSpPr>
        <p:grpSpPr>
          <a:xfrm>
            <a:off x="1628640" y="2987640"/>
            <a:ext cx="3598200" cy="1814040"/>
            <a:chOff x="1628640" y="2987640"/>
            <a:chExt cx="3598200" cy="1814040"/>
          </a:xfrm>
        </p:grpSpPr>
        <p:grpSp>
          <p:nvGrpSpPr>
            <p:cNvPr id="43" name="Group 40"/>
            <p:cNvGrpSpPr/>
            <p:nvPr/>
          </p:nvGrpSpPr>
          <p:grpSpPr>
            <a:xfrm>
              <a:off x="1670760" y="2987640"/>
              <a:ext cx="1434600" cy="1814040"/>
              <a:chOff x="1670760" y="2987640"/>
              <a:chExt cx="1434600" cy="1814040"/>
            </a:xfrm>
          </p:grpSpPr>
          <p:sp>
            <p:nvSpPr>
              <p:cNvPr id="44" name="CuadroTexto 12"/>
              <p:cNvSpPr/>
              <p:nvPr/>
            </p:nvSpPr>
            <p:spPr>
              <a:xfrm>
                <a:off x="1761480" y="2987640"/>
                <a:ext cx="105984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ALL-MN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5" name="Conector recto de flecha 13"/>
              <p:cNvCxnSpPr/>
              <p:nvPr/>
            </p:nvCxnSpPr>
            <p:spPr>
              <a:xfrm flipH="1">
                <a:off x="1670760" y="4478040"/>
                <a:ext cx="1181880" cy="108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46" name="CuadroTexto 15"/>
              <p:cNvSpPr/>
              <p:nvPr/>
            </p:nvSpPr>
            <p:spPr>
              <a:xfrm>
                <a:off x="1682640" y="4435920"/>
                <a:ext cx="142272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Cell Trace Viole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Text Box 16"/>
            <p:cNvSpPr/>
            <p:nvPr/>
          </p:nvSpPr>
          <p:spPr>
            <a:xfrm>
              <a:off x="2982960" y="3218760"/>
              <a:ext cx="77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NBM-MS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onector recto 17"/>
            <p:cNvSpPr/>
            <p:nvPr/>
          </p:nvSpPr>
          <p:spPr>
            <a:xfrm>
              <a:off x="2895480" y="3335040"/>
              <a:ext cx="161640" cy="0"/>
            </a:xfrm>
            <a:prstGeom prst="line">
              <a:avLst/>
            </a:prstGeom>
            <a:ln w="38160">
              <a:solidFill>
                <a:srgbClr val="4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onector recto 18"/>
            <p:cNvSpPr/>
            <p:nvPr/>
          </p:nvSpPr>
          <p:spPr>
            <a:xfrm>
              <a:off x="2895480" y="3480840"/>
              <a:ext cx="161640" cy="0"/>
            </a:xfrm>
            <a:prstGeom prst="line">
              <a:avLst/>
            </a:prstGeom>
            <a:ln w="38160">
              <a:solidFill>
                <a:srgbClr val="ff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6"/>
            <p:cNvSpPr/>
            <p:nvPr/>
          </p:nvSpPr>
          <p:spPr>
            <a:xfrm>
              <a:off x="2989080" y="3360240"/>
              <a:ext cx="736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ALL-MS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Picture 49" descr=""/>
            <p:cNvPicPr/>
            <p:nvPr/>
          </p:nvPicPr>
          <p:blipFill>
            <a:blip r:embed="rId1"/>
            <a:srcRect l="4837" t="0" r="42453" b="3724"/>
            <a:stretch/>
          </p:blipFill>
          <p:spPr>
            <a:xfrm>
              <a:off x="1628640" y="3265920"/>
              <a:ext cx="1217880" cy="123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50" descr=""/>
            <p:cNvPicPr/>
            <p:nvPr/>
          </p:nvPicPr>
          <p:blipFill>
            <a:blip r:embed="rId2"/>
            <a:srcRect l="14281" t="0" r="21279" b="22974"/>
            <a:stretch/>
          </p:blipFill>
          <p:spPr>
            <a:xfrm>
              <a:off x="3894840" y="3265920"/>
              <a:ext cx="1279800" cy="115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 Box 16"/>
            <p:cNvSpPr/>
            <p:nvPr/>
          </p:nvSpPr>
          <p:spPr>
            <a:xfrm>
              <a:off x="4164120" y="438228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N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6"/>
            <p:cNvSpPr/>
            <p:nvPr/>
          </p:nvSpPr>
          <p:spPr>
            <a:xfrm>
              <a:off x="4707720" y="439236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AL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0"/>
            <p:cNvSpPr/>
            <p:nvPr/>
          </p:nvSpPr>
          <p:spPr>
            <a:xfrm rot="16200000">
              <a:off x="3345120" y="3678480"/>
              <a:ext cx="104652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Proliferation (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CuadroTexto 27"/>
            <p:cNvSpPr/>
            <p:nvPr/>
          </p:nvSpPr>
          <p:spPr>
            <a:xfrm>
              <a:off x="4692600" y="3475440"/>
              <a:ext cx="5342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s-ES" sz="8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p=0.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CuadroTexto 27"/>
            <p:cNvSpPr/>
            <p:nvPr/>
          </p:nvSpPr>
          <p:spPr>
            <a:xfrm>
              <a:off x="4836600" y="3601440"/>
              <a:ext cx="23256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b">
              <a:spAutoFit/>
            </a:bodyPr>
            <a:p>
              <a:pPr>
                <a:lnSpc>
                  <a:spcPct val="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2T03:08:14Z</dcterms:created>
  <dc:creator>PELAYO</dc:creator>
  <dc:description/>
  <dc:language>en-US</dc:language>
  <cp:lastModifiedBy>PELAYO</cp:lastModifiedBy>
  <dcterms:modified xsi:type="dcterms:W3CDTF">2016-12-14T20:27:41Z</dcterms:modified>
  <cp:revision>6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3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3.PPT</vt:lpwstr>
  </property>
</Properties>
</file>